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6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 varScale="1">
        <p:scale>
          <a:sx n="85" d="100"/>
          <a:sy n="85" d="100"/>
        </p:scale>
        <p:origin x="3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5" Type="http://schemas.openxmlformats.org/officeDocument/2006/relationships/image" Target="../media/image4.emf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7445E07-3E83-6A10-3CA3-B1211545C92A}"/>
              </a:ext>
            </a:extLst>
          </p:cNvPr>
          <p:cNvSpPr txBox="1"/>
          <p:nvPr/>
        </p:nvSpPr>
        <p:spPr>
          <a:xfrm>
            <a:off x="0" y="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C3105A7-FB79-064A-6C51-798D971C3F68}"/>
              </a:ext>
            </a:extLst>
          </p:cNvPr>
          <p:cNvSpPr txBox="1"/>
          <p:nvPr/>
        </p:nvSpPr>
        <p:spPr>
          <a:xfrm>
            <a:off x="-12392" y="37314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6BA080-E7B8-9903-DBC8-986433909AB4}"/>
              </a:ext>
            </a:extLst>
          </p:cNvPr>
          <p:cNvSpPr txBox="1"/>
          <p:nvPr/>
        </p:nvSpPr>
        <p:spPr>
          <a:xfrm>
            <a:off x="-13829" y="742479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i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5E8ACC4-958A-F116-7C50-826E0A5D246C}"/>
              </a:ext>
            </a:extLst>
          </p:cNvPr>
          <p:cNvSpPr txBox="1"/>
          <p:nvPr/>
        </p:nvSpPr>
        <p:spPr>
          <a:xfrm>
            <a:off x="2308072" y="74247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i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8CF9051-0F61-0336-B553-FF63E457DC19}"/>
              </a:ext>
            </a:extLst>
          </p:cNvPr>
          <p:cNvSpPr txBox="1"/>
          <p:nvPr/>
        </p:nvSpPr>
        <p:spPr>
          <a:xfrm>
            <a:off x="4542063" y="742479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ii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EF00774-6250-FBC1-9DB1-28A7FBE4C58D}"/>
              </a:ext>
            </a:extLst>
          </p:cNvPr>
          <p:cNvSpPr txBox="1"/>
          <p:nvPr/>
        </p:nvSpPr>
        <p:spPr>
          <a:xfrm>
            <a:off x="-26900" y="2155354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v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54FE77E-AC26-4344-FC44-ACAD056B7493}"/>
              </a:ext>
            </a:extLst>
          </p:cNvPr>
          <p:cNvSpPr txBox="1"/>
          <p:nvPr/>
        </p:nvSpPr>
        <p:spPr>
          <a:xfrm>
            <a:off x="2332520" y="2151539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C65E629-F2F4-971D-1FA4-A170FDE3D256}"/>
              </a:ext>
            </a:extLst>
          </p:cNvPr>
          <p:cNvSpPr txBox="1"/>
          <p:nvPr/>
        </p:nvSpPr>
        <p:spPr>
          <a:xfrm>
            <a:off x="0" y="379514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C143185-A5D9-63E7-7C17-6BB5271644A5}"/>
              </a:ext>
            </a:extLst>
          </p:cNvPr>
          <p:cNvSpPr txBox="1"/>
          <p:nvPr/>
        </p:nvSpPr>
        <p:spPr>
          <a:xfrm>
            <a:off x="209321" y="3860347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i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65D0660-4997-EC06-E567-B0DE7B8DA45E}"/>
              </a:ext>
            </a:extLst>
          </p:cNvPr>
          <p:cNvSpPr txBox="1"/>
          <p:nvPr/>
        </p:nvSpPr>
        <p:spPr>
          <a:xfrm>
            <a:off x="2511846" y="386034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i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B87A157-B25F-7C37-E83E-6F49A38D93B6}"/>
              </a:ext>
            </a:extLst>
          </p:cNvPr>
          <p:cNvSpPr txBox="1"/>
          <p:nvPr/>
        </p:nvSpPr>
        <p:spPr>
          <a:xfrm>
            <a:off x="4847422" y="3860347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ii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5C19E76-5A20-38F2-7DBE-6C9E69405B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3045"/>
          <a:stretch/>
        </p:blipFill>
        <p:spPr>
          <a:xfrm>
            <a:off x="303735" y="478766"/>
            <a:ext cx="1981832" cy="17233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7AA94AE-FCDB-FC69-E013-55664A7B423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3045"/>
          <a:stretch/>
        </p:blipFill>
        <p:spPr>
          <a:xfrm>
            <a:off x="2577948" y="478764"/>
            <a:ext cx="1981832" cy="1723307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CC03AC3-81D6-D6FA-92B5-9AFD9FF062D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3045"/>
          <a:stretch/>
        </p:blipFill>
        <p:spPr>
          <a:xfrm>
            <a:off x="4885428" y="478764"/>
            <a:ext cx="1981832" cy="1723307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32605AF-2773-C7AD-A9E5-52CB21F3635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2898"/>
          <a:stretch/>
        </p:blipFill>
        <p:spPr>
          <a:xfrm>
            <a:off x="314860" y="2151539"/>
            <a:ext cx="1978499" cy="172330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281928A4-8ECE-D3B4-C944-76591D371D8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2898"/>
          <a:stretch/>
        </p:blipFill>
        <p:spPr>
          <a:xfrm>
            <a:off x="2652224" y="2151539"/>
            <a:ext cx="1978499" cy="172330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360C0D3-E1B4-62EA-9AF7-0AB784403DF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732" y="4160603"/>
            <a:ext cx="2266080" cy="22660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E22B11-6743-324E-EE44-C697146A9C5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41728" y="4160602"/>
            <a:ext cx="2264678" cy="226467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A2D5F1B-8AC4-46D2-C170-DB4B7D46450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93322" y="4160602"/>
            <a:ext cx="2264678" cy="226467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7D64A5E-EEF3-F11C-A6D5-B57AD894D4E5}"/>
              </a:ext>
            </a:extLst>
          </p:cNvPr>
          <p:cNvSpPr txBox="1"/>
          <p:nvPr/>
        </p:nvSpPr>
        <p:spPr>
          <a:xfrm>
            <a:off x="-13829" y="8733044"/>
            <a:ext cx="6871829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spcBef>
                <a:spcPts val="300"/>
              </a:spcBef>
            </a:pPr>
            <a:r>
              <a:rPr lang="en-US" sz="9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8. T cell receptor (TCR) clonotype analysis in tumor, pre-REP TIL and TIL samples</a:t>
            </a:r>
            <a:endParaRPr lang="en-US" sz="9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v. The proportion of clonotypes present in each patient’s corresponding tumor (T), pre-REP TIL and REP TIL TCR repertoires. Generally, the pre-REP TILs were dominated by the top 10 most abundant clones in the repertoire.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v. Tracking the 20 most abundant REP TIL clonotypes between the corresponding tumor and pre-REP TIL samples for five patients. Overall, little overlap was observed between the pre-REP TIL and REP TIL samples. Samples with the corresponding healthy kidney tissue (H) showed no shared clonotypes with the tumor (T) samples in two patients (pt423 and pt426).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2DA814C-0C85-FBA2-007E-6DB570872989}"/>
              </a:ext>
            </a:extLst>
          </p:cNvPr>
          <p:cNvSpPr txBox="1"/>
          <p:nvPr/>
        </p:nvSpPr>
        <p:spPr>
          <a:xfrm>
            <a:off x="209321" y="6086801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v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A0B8172-9974-F03B-2928-4F91E7EE543E}"/>
              </a:ext>
            </a:extLst>
          </p:cNvPr>
          <p:cNvSpPr txBox="1"/>
          <p:nvPr/>
        </p:nvSpPr>
        <p:spPr>
          <a:xfrm>
            <a:off x="2511846" y="6086801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2F631263-53A0-00C3-1BBE-AEC54A78F8A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134" y="6456133"/>
            <a:ext cx="2264678" cy="226467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11EBFF5-9B47-888C-BF4D-DD7EEACAE30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41727" y="6462249"/>
            <a:ext cx="2264679" cy="22646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7612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93</TotalTime>
  <Words>143</Words>
  <Application>Microsoft Macintosh PowerPoint</Application>
  <PresentationFormat>A4-paperi (210 x 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5</cp:revision>
  <dcterms:created xsi:type="dcterms:W3CDTF">2022-10-13T13:05:53Z</dcterms:created>
  <dcterms:modified xsi:type="dcterms:W3CDTF">2023-06-17T07:26:04Z</dcterms:modified>
</cp:coreProperties>
</file>